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Utilisateur Microsoft Office" initials="UMO" lastIdx="2" clrIdx="0">
    <p:extLst>
      <p:ext uri="{19B8F6BF-5375-455C-9EA6-DF929625EA0E}">
        <p15:presenceInfo xmlns:p15="http://schemas.microsoft.com/office/powerpoint/2012/main" userId="Utilisateur Microsoft Offic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568"/>
    <p:restoredTop sz="94697"/>
  </p:normalViewPr>
  <p:slideViewPr>
    <p:cSldViewPr snapToGrid="0" snapToObjects="1" showGuides="1">
      <p:cViewPr varScale="1">
        <p:scale>
          <a:sx n="97" d="100"/>
          <a:sy n="97" d="100"/>
        </p:scale>
        <p:origin x="1136" y="1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887006998510109"/>
          <c:y val="0.12565248801705406"/>
          <c:w val="0.82668553471466677"/>
          <c:h val="0.5595822860148118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0 h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G$2:$G$4</c:f>
                <c:numCache>
                  <c:formatCode>General</c:formatCode>
                  <c:ptCount val="3"/>
                  <c:pt idx="0">
                    <c:v>0.20764067817883886</c:v>
                  </c:pt>
                  <c:pt idx="1">
                    <c:v>0.39532640444243394</c:v>
                  </c:pt>
                  <c:pt idx="2">
                    <c:v>0.30394013380643164</c:v>
                  </c:pt>
                </c:numCache>
              </c:numRef>
            </c:plus>
            <c:minus>
              <c:numRef>
                <c:f>Sheet1!$G$2:$G$4</c:f>
                <c:numCache>
                  <c:formatCode>General</c:formatCode>
                  <c:ptCount val="3"/>
                  <c:pt idx="0">
                    <c:v>0.20764067817883886</c:v>
                  </c:pt>
                  <c:pt idx="1">
                    <c:v>0.39532640444243394</c:v>
                  </c:pt>
                  <c:pt idx="2">
                    <c:v>0.30394013380643164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4</c:f>
              <c:strCache>
                <c:ptCount val="3"/>
                <c:pt idx="0">
                  <c:v>PEG 4000</c:v>
                </c:pt>
                <c:pt idx="1">
                  <c:v>PEG 6000</c:v>
                </c:pt>
                <c:pt idx="2">
                  <c:v>PEG 8000</c:v>
                </c:pt>
              </c:strCache>
            </c:strRef>
          </c:cat>
          <c:val>
            <c:numRef>
              <c:f>Sheet1!$B$2:$B$4</c:f>
              <c:numCache>
                <c:formatCode>0</c:formatCode>
                <c:ptCount val="3"/>
                <c:pt idx="0">
                  <c:v>16.354277777777778</c:v>
                </c:pt>
                <c:pt idx="1">
                  <c:v>12.974555555555558</c:v>
                </c:pt>
                <c:pt idx="2">
                  <c:v>8.59922222222222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77C-A740-88C5-4A1547C5F2BC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2 h</c:v>
                </c:pt>
              </c:strCache>
            </c:strRef>
          </c:tx>
          <c:spPr>
            <a:solidFill>
              <a:schemeClr val="accent6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H$2:$H$4</c:f>
                <c:numCache>
                  <c:formatCode>General</c:formatCode>
                  <c:ptCount val="3"/>
                  <c:pt idx="0">
                    <c:v>0.56553170927679319</c:v>
                  </c:pt>
                  <c:pt idx="1">
                    <c:v>0.44336650182244425</c:v>
                  </c:pt>
                  <c:pt idx="2">
                    <c:v>0.15092628607091765</c:v>
                  </c:pt>
                </c:numCache>
              </c:numRef>
            </c:plus>
            <c:minus>
              <c:numRef>
                <c:f>Sheet1!$H$2:$H$4</c:f>
                <c:numCache>
                  <c:formatCode>General</c:formatCode>
                  <c:ptCount val="3"/>
                  <c:pt idx="0">
                    <c:v>0.56553170927679319</c:v>
                  </c:pt>
                  <c:pt idx="1">
                    <c:v>0.44336650182244425</c:v>
                  </c:pt>
                  <c:pt idx="2">
                    <c:v>0.15092628607091765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4</c:f>
              <c:strCache>
                <c:ptCount val="3"/>
                <c:pt idx="0">
                  <c:v>PEG 4000</c:v>
                </c:pt>
                <c:pt idx="1">
                  <c:v>PEG 6000</c:v>
                </c:pt>
                <c:pt idx="2">
                  <c:v>PEG 8000</c:v>
                </c:pt>
              </c:strCache>
            </c:strRef>
          </c:cat>
          <c:val>
            <c:numRef>
              <c:f>Sheet1!$C$2:$C$4</c:f>
              <c:numCache>
                <c:formatCode>0</c:formatCode>
                <c:ptCount val="3"/>
                <c:pt idx="0">
                  <c:v>16.363222222222223</c:v>
                </c:pt>
                <c:pt idx="1">
                  <c:v>12.301722222222223</c:v>
                </c:pt>
                <c:pt idx="2">
                  <c:v>6.82338888888888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77C-A740-88C5-4A1547C5F2BC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24 h</c:v>
                </c:pt>
              </c:strCache>
            </c:strRef>
          </c:tx>
          <c:spPr>
            <a:pattFill prst="openDmnd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I$2:$I$4</c:f>
                <c:numCache>
                  <c:formatCode>General</c:formatCode>
                  <c:ptCount val="3"/>
                  <c:pt idx="0">
                    <c:v>0.31198905389946985</c:v>
                  </c:pt>
                  <c:pt idx="1">
                    <c:v>1.5979612126197063</c:v>
                  </c:pt>
                  <c:pt idx="2">
                    <c:v>0.16173515158820398</c:v>
                  </c:pt>
                </c:numCache>
              </c:numRef>
            </c:plus>
            <c:minus>
              <c:numRef>
                <c:f>Sheet1!$I$2:$I$4</c:f>
                <c:numCache>
                  <c:formatCode>General</c:formatCode>
                  <c:ptCount val="3"/>
                  <c:pt idx="0">
                    <c:v>0.31198905389946985</c:v>
                  </c:pt>
                  <c:pt idx="1">
                    <c:v>1.5979612126197063</c:v>
                  </c:pt>
                  <c:pt idx="2">
                    <c:v>0.16173515158820398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4</c:f>
              <c:strCache>
                <c:ptCount val="3"/>
                <c:pt idx="0">
                  <c:v>PEG 4000</c:v>
                </c:pt>
                <c:pt idx="1">
                  <c:v>PEG 6000</c:v>
                </c:pt>
                <c:pt idx="2">
                  <c:v>PEG 8000</c:v>
                </c:pt>
              </c:strCache>
            </c:strRef>
          </c:cat>
          <c:val>
            <c:numRef>
              <c:f>Sheet1!$D$2:$D$4</c:f>
              <c:numCache>
                <c:formatCode>0</c:formatCode>
                <c:ptCount val="3"/>
                <c:pt idx="0">
                  <c:v>15.74888888888889</c:v>
                </c:pt>
                <c:pt idx="1">
                  <c:v>13.240833333333335</c:v>
                </c:pt>
                <c:pt idx="2">
                  <c:v>5.3635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77C-A740-88C5-4A1547C5F2B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98"/>
        <c:overlap val="-27"/>
        <c:axId val="1822880496"/>
        <c:axId val="1822882176"/>
      </c:barChart>
      <c:catAx>
        <c:axId val="18228804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1822882176"/>
        <c:crosses val="autoZero"/>
        <c:auto val="1"/>
        <c:lblAlgn val="ctr"/>
        <c:lblOffset val="100"/>
        <c:noMultiLvlLbl val="0"/>
      </c:catAx>
      <c:valAx>
        <c:axId val="182288217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GB" dirty="0"/>
                  <a:t>Millions of viable cells.mL</a:t>
                </a:r>
                <a:r>
                  <a:rPr lang="en-GB" baseline="30000" dirty="0"/>
                  <a:t>-1</a:t>
                </a:r>
                <a:endParaRPr lang="fr-FR" baseline="30000" dirty="0"/>
              </a:p>
            </c:rich>
          </c:tx>
          <c:layout>
            <c:manualLayout>
              <c:xMode val="edge"/>
              <c:yMode val="edge"/>
              <c:x val="9.2112039935026355E-3"/>
              <c:y val="9.2376298087498518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fr-FR"/>
            </a:p>
          </c:txPr>
        </c:title>
        <c:numFmt formatCode="0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182288049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3591595893146353"/>
          <c:y val="0.76908978689499607"/>
          <c:w val="0.47105378271471843"/>
          <c:h val="9.021461357426156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6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fr-F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0 h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G$2:$G$5</c:f>
                <c:numCache>
                  <c:formatCode>General</c:formatCode>
                  <c:ptCount val="4"/>
                  <c:pt idx="0">
                    <c:v>0.4282464928542622</c:v>
                  </c:pt>
                  <c:pt idx="1">
                    <c:v>0.20764067817883886</c:v>
                  </c:pt>
                  <c:pt idx="2">
                    <c:v>0.38982146910833199</c:v>
                  </c:pt>
                  <c:pt idx="3">
                    <c:v>5.5728591637739258E-2</c:v>
                  </c:pt>
                </c:numCache>
              </c:numRef>
            </c:plus>
            <c:minus>
              <c:numRef>
                <c:f>Sheet1!$G$2:$G$5</c:f>
                <c:numCache>
                  <c:formatCode>General</c:formatCode>
                  <c:ptCount val="4"/>
                  <c:pt idx="0">
                    <c:v>0.4282464928542622</c:v>
                  </c:pt>
                  <c:pt idx="1">
                    <c:v>0.20764067817883886</c:v>
                  </c:pt>
                  <c:pt idx="2">
                    <c:v>0.38982146910833199</c:v>
                  </c:pt>
                  <c:pt idx="3">
                    <c:v>5.5728591637739258E-2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5</c:f>
              <c:strCache>
                <c:ptCount val="4"/>
                <c:pt idx="0">
                  <c:v>control</c:v>
                </c:pt>
                <c:pt idx="1">
                  <c:v>2 min</c:v>
                </c:pt>
                <c:pt idx="2">
                  <c:v>5 min</c:v>
                </c:pt>
                <c:pt idx="3">
                  <c:v>20 min</c:v>
                </c:pt>
              </c:strCache>
            </c:strRef>
          </c:cat>
          <c:val>
            <c:numRef>
              <c:f>Sheet1!$B$2:$B$5</c:f>
              <c:numCache>
                <c:formatCode>0</c:formatCode>
                <c:ptCount val="4"/>
                <c:pt idx="0">
                  <c:v>17.236055555555602</c:v>
                </c:pt>
                <c:pt idx="1">
                  <c:v>16.354277777777778</c:v>
                </c:pt>
                <c:pt idx="2">
                  <c:v>16.782833333333333</c:v>
                </c:pt>
                <c:pt idx="3">
                  <c:v>17.437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B3C-E146-862F-0812D6D226DB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2 h</c:v>
                </c:pt>
              </c:strCache>
            </c:strRef>
          </c:tx>
          <c:spPr>
            <a:solidFill>
              <a:schemeClr val="accent6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H$2:$H$5</c:f>
                <c:numCache>
                  <c:formatCode>General</c:formatCode>
                  <c:ptCount val="4"/>
                  <c:pt idx="0">
                    <c:v>0.53743651936361725</c:v>
                  </c:pt>
                  <c:pt idx="1">
                    <c:v>0.56553170927679319</c:v>
                  </c:pt>
                  <c:pt idx="2">
                    <c:v>0.21635278546341341</c:v>
                  </c:pt>
                  <c:pt idx="3">
                    <c:v>5.3508825855595486E-2</c:v>
                  </c:pt>
                </c:numCache>
              </c:numRef>
            </c:plus>
            <c:minus>
              <c:numRef>
                <c:f>Sheet1!$H$2:$H$5</c:f>
                <c:numCache>
                  <c:formatCode>General</c:formatCode>
                  <c:ptCount val="4"/>
                  <c:pt idx="0">
                    <c:v>0.53743651936361725</c:v>
                  </c:pt>
                  <c:pt idx="1">
                    <c:v>0.56553170927679319</c:v>
                  </c:pt>
                  <c:pt idx="2">
                    <c:v>0.21635278546341341</c:v>
                  </c:pt>
                  <c:pt idx="3">
                    <c:v>5.3508825855595486E-2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5</c:f>
              <c:strCache>
                <c:ptCount val="4"/>
                <c:pt idx="0">
                  <c:v>control</c:v>
                </c:pt>
                <c:pt idx="1">
                  <c:v>2 min</c:v>
                </c:pt>
                <c:pt idx="2">
                  <c:v>5 min</c:v>
                </c:pt>
                <c:pt idx="3">
                  <c:v>20 min</c:v>
                </c:pt>
              </c:strCache>
            </c:strRef>
          </c:cat>
          <c:val>
            <c:numRef>
              <c:f>Sheet1!$C$2:$C$5</c:f>
              <c:numCache>
                <c:formatCode>0</c:formatCode>
                <c:ptCount val="4"/>
                <c:pt idx="0">
                  <c:v>17.893555555555555</c:v>
                </c:pt>
                <c:pt idx="1">
                  <c:v>16.363222222222223</c:v>
                </c:pt>
                <c:pt idx="2">
                  <c:v>16.703666666666667</c:v>
                </c:pt>
                <c:pt idx="3">
                  <c:v>16.0176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B3C-E146-862F-0812D6D226DB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24 h</c:v>
                </c:pt>
              </c:strCache>
            </c:strRef>
          </c:tx>
          <c:spPr>
            <a:pattFill prst="openDmnd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I$2:$I$5</c:f>
                <c:numCache>
                  <c:formatCode>General</c:formatCode>
                  <c:ptCount val="4"/>
                  <c:pt idx="0">
                    <c:v>0.93685356643302176</c:v>
                  </c:pt>
                  <c:pt idx="1">
                    <c:v>0.31198905389946985</c:v>
                  </c:pt>
                  <c:pt idx="2">
                    <c:v>0.42358532526254705</c:v>
                  </c:pt>
                  <c:pt idx="3">
                    <c:v>0.28799081025290291</c:v>
                  </c:pt>
                </c:numCache>
              </c:numRef>
            </c:plus>
            <c:minus>
              <c:numRef>
                <c:f>Sheet1!$I$2:$I$5</c:f>
                <c:numCache>
                  <c:formatCode>General</c:formatCode>
                  <c:ptCount val="4"/>
                  <c:pt idx="0">
                    <c:v>0.93685356643302176</c:v>
                  </c:pt>
                  <c:pt idx="1">
                    <c:v>0.31198905389946985</c:v>
                  </c:pt>
                  <c:pt idx="2">
                    <c:v>0.42358532526254705</c:v>
                  </c:pt>
                  <c:pt idx="3">
                    <c:v>0.28799081025290291</c:v>
                  </c:pt>
                </c:numCache>
              </c:numRef>
            </c:minus>
            <c:spPr>
              <a:noFill/>
              <a:ln w="2540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A$2:$A$5</c:f>
              <c:strCache>
                <c:ptCount val="4"/>
                <c:pt idx="0">
                  <c:v>control</c:v>
                </c:pt>
                <c:pt idx="1">
                  <c:v>2 min</c:v>
                </c:pt>
                <c:pt idx="2">
                  <c:v>5 min</c:v>
                </c:pt>
                <c:pt idx="3">
                  <c:v>20 min</c:v>
                </c:pt>
              </c:strCache>
            </c:strRef>
          </c:cat>
          <c:val>
            <c:numRef>
              <c:f>Sheet1!$D$2:$D$5</c:f>
              <c:numCache>
                <c:formatCode>0</c:formatCode>
                <c:ptCount val="4"/>
                <c:pt idx="0">
                  <c:v>26.693444444444449</c:v>
                </c:pt>
                <c:pt idx="1">
                  <c:v>15.74888888888889</c:v>
                </c:pt>
                <c:pt idx="2">
                  <c:v>15.891333333333334</c:v>
                </c:pt>
                <c:pt idx="3">
                  <c:v>12.2015555555555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B3C-E146-862F-0812D6D226D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26"/>
        <c:overlap val="-27"/>
        <c:axId val="1822880496"/>
        <c:axId val="1822882176"/>
      </c:barChart>
      <c:catAx>
        <c:axId val="18228804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1822882176"/>
        <c:crosses val="autoZero"/>
        <c:auto val="1"/>
        <c:lblAlgn val="ctr"/>
        <c:lblOffset val="100"/>
        <c:noMultiLvlLbl val="0"/>
      </c:catAx>
      <c:valAx>
        <c:axId val="182288217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GB" sz="1600" dirty="0"/>
                  <a:t>Millions of viable cells.mL</a:t>
                </a:r>
                <a:r>
                  <a:rPr lang="en-GB" sz="1600" baseline="30000" dirty="0"/>
                  <a:t>-1</a:t>
                </a:r>
              </a:p>
            </c:rich>
          </c:tx>
          <c:layout>
            <c:manualLayout>
              <c:xMode val="edge"/>
              <c:yMode val="edge"/>
              <c:x val="2.9983760461172394E-2"/>
              <c:y val="1.5231853855847759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fr-FR"/>
            </a:p>
          </c:txPr>
        </c:title>
        <c:numFmt formatCode="0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fr-FR"/>
          </a:p>
        </c:txPr>
        <c:crossAx val="182288049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144491941433053"/>
          <c:y val="0.85684888213780552"/>
          <c:w val="0.44029454186593792"/>
          <c:h val="0.1007188440207679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6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89BED6-4D7D-C141-A2F0-0D0B12A29EE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D6CE0AD-B406-0F44-9E00-CE9C0217711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7AD695-AAB1-4A47-8211-9D3DF13E8C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33566-0E52-144F-9AC0-FBA623AD1680}" type="datetimeFigureOut">
              <a:rPr lang="en-GB" smtClean="0"/>
              <a:t>24/05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EC80B3-F542-F442-A13B-82AEFDB3DE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1EF036-04DF-904A-A882-56314F3F5D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EF6CA-E162-5346-8F58-DDDA756B8E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363630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1F61E2-D71F-004F-B9F0-699DD3D8E1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85CF683-F153-EE4E-AAA1-37763B51B8C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F98032-DFFE-0641-A644-691D57DF95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33566-0E52-144F-9AC0-FBA623AD1680}" type="datetimeFigureOut">
              <a:rPr lang="en-GB" smtClean="0"/>
              <a:t>24/05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AD4089-EC84-9D46-9B82-4308F392F2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2739BD-5903-0442-9F14-5AA2CC9766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EF6CA-E162-5346-8F58-DDDA756B8E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410715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1BEB42C-2D8B-8049-BF82-6593B6A9F69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44B4368-B6F7-F948-9EB6-83808DBDCB0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6EBE18-0002-CD44-B02E-CC79894C25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33566-0E52-144F-9AC0-FBA623AD1680}" type="datetimeFigureOut">
              <a:rPr lang="en-GB" smtClean="0"/>
              <a:t>24/05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18A52E-0597-D547-9E23-1F3DF2C5F1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A22012-E7AB-4B49-BB81-9901615362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EF6CA-E162-5346-8F58-DDDA756B8E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607896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B6922F-DC3D-7346-A73C-4FBD765EBE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2F9BF3A-CBCB-5747-820E-167587DE50F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393C1D-1204-BC48-97C6-520A2E86E8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33566-0E52-144F-9AC0-FBA623AD1680}" type="datetimeFigureOut">
              <a:rPr lang="en-GB" smtClean="0"/>
              <a:t>24/05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B9CA6E-899D-744E-821D-5C2473B2FA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746FC4-DF13-5440-BE26-70E80A3E92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EF6CA-E162-5346-8F58-DDDA756B8E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437177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F19AA6-7EC0-7743-9E65-848BE251E1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D85E6C9-738B-7346-91EF-4DDC1E5F59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61AA99-5FBC-F944-85AF-998F02E060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33566-0E52-144F-9AC0-FBA623AD1680}" type="datetimeFigureOut">
              <a:rPr lang="en-GB" smtClean="0"/>
              <a:t>24/05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E937C4-DC36-9245-9A20-821799CFB3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9A3442-2E5E-E24E-B4F7-AB322CB159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EF6CA-E162-5346-8F58-DDDA756B8E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01894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CC1DA0-98E8-B844-AC5A-47B72271AE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1BDA94-BA7B-5A44-BDC8-BC79466E49A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4DA8128-A984-1C43-A484-B10FF950DFB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D9C19D3-6A2A-E544-9F1C-C3044B9101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33566-0E52-144F-9AC0-FBA623AD1680}" type="datetimeFigureOut">
              <a:rPr lang="en-GB" smtClean="0"/>
              <a:t>24/05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67C23C-7916-D044-903A-7CC267C56F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B7D187C-4104-5142-978E-DEAA9F9809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EF6CA-E162-5346-8F58-DDDA756B8E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087874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4B6E1B-259B-3C4E-8506-F155FDA9D2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C7AC096-024F-9342-97A7-CCA3583007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C18282B-5C7E-E047-A973-56CB32A59B0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0926433-2D23-A041-8A0D-192217388DF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3CABC83-ABB0-E943-979D-AF3F9736B22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4FEB253-A6F9-6A48-B443-F07D7B8927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33566-0E52-144F-9AC0-FBA623AD1680}" type="datetimeFigureOut">
              <a:rPr lang="en-GB" smtClean="0"/>
              <a:t>24/05/2019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443987D-37AB-6247-BD0E-5D9E6D44DF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BB41792-91CA-894C-851E-8DD6EF9F24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EF6CA-E162-5346-8F58-DDDA756B8E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85796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3766F0-BC45-664A-BF36-C8597D4B42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0A54761-BAD9-8F4D-88E8-DE2942F7CB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33566-0E52-144F-9AC0-FBA623AD1680}" type="datetimeFigureOut">
              <a:rPr lang="en-GB" smtClean="0"/>
              <a:t>24/05/2019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2657185-D945-8346-BEF8-AED4C79112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E6B6D81-0480-7E43-9E4E-48DA38D7EA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EF6CA-E162-5346-8F58-DDDA756B8E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73132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7A168C6-97EF-7146-BBB9-688B3082D4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33566-0E52-144F-9AC0-FBA623AD1680}" type="datetimeFigureOut">
              <a:rPr lang="en-GB" smtClean="0"/>
              <a:t>24/05/2019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6CA2B24-4DD5-2B47-B4B2-DDD70EEAA5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6AF9B1D-3610-5646-AB3C-F9044A7133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EF6CA-E162-5346-8F58-DDDA756B8E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74298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F8762C-4A92-DE44-B4CA-FC71636BA9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FD1AF22-13C8-BB44-BCB4-DC5947EF4D4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DEB8343-FB59-454A-9E0F-43596B0FE6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082DE23-293E-4D48-BCE2-BFB6811CC5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33566-0E52-144F-9AC0-FBA623AD1680}" type="datetimeFigureOut">
              <a:rPr lang="en-GB" smtClean="0"/>
              <a:t>24/05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7666F8F-1357-1E47-B50E-20E30C42D4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62B1AC2-7389-9C4F-9CCF-E61F0774C9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EF6CA-E162-5346-8F58-DDDA756B8E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08940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28F2CA-2F55-B74C-9B6E-E3B8434618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E9CB22B-8794-0242-95A5-936ED21DC94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671F24E-A5B2-314C-BAFE-E164BC9A73D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00E2CDD-1C0B-874A-93C2-E52B72F8CD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33566-0E52-144F-9AC0-FBA623AD1680}" type="datetimeFigureOut">
              <a:rPr lang="en-GB" smtClean="0"/>
              <a:t>24/05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B691ABE-D044-7E42-8307-1E7E2E6B91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1666637-A1D3-9844-8C94-761E30747C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0EF6CA-E162-5346-8F58-DDDA756B8E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98451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515912C-14B7-1241-8CE0-B11F499C8E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3DBF893-3C6C-AC48-A6B8-08DFD3CBDE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070888-C76F-2348-B8DF-A3DCFA99913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633566-0E52-144F-9AC0-FBA623AD1680}" type="datetimeFigureOut">
              <a:rPr lang="en-GB" smtClean="0"/>
              <a:t>24/05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9DFA0E-647B-9748-AF7D-2109051B4DE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33BDCD-6E75-024F-9F0E-3AEDBA98C7F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0EF6CA-E162-5346-8F58-DDDA756B8E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55630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1A7AB3A0-D5C5-9E4D-AEEB-F62BFA6AA699}"/>
              </a:ext>
            </a:extLst>
          </p:cNvPr>
          <p:cNvGrpSpPr/>
          <p:nvPr/>
        </p:nvGrpSpPr>
        <p:grpSpPr>
          <a:xfrm>
            <a:off x="6096000" y="501230"/>
            <a:ext cx="5895779" cy="4636692"/>
            <a:chOff x="4644229" y="3150746"/>
            <a:chExt cx="5109062" cy="4292621"/>
          </a:xfrm>
        </p:grpSpPr>
        <p:graphicFrame>
          <p:nvGraphicFramePr>
            <p:cNvPr id="11" name="Chart 10">
              <a:extLst>
                <a:ext uri="{FF2B5EF4-FFF2-40B4-BE49-F238E27FC236}">
                  <a16:creationId xmlns:a16="http://schemas.microsoft.com/office/drawing/2014/main" id="{01F6752F-4773-1C46-A2F9-3BDC1708D59F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976534849"/>
                </p:ext>
              </p:extLst>
            </p:nvPr>
          </p:nvGraphicFramePr>
          <p:xfrm>
            <a:off x="4644229" y="3466210"/>
            <a:ext cx="5109062" cy="397715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39C789AF-5D6E-2A42-B636-D6F774570766}"/>
                </a:ext>
              </a:extLst>
            </p:cNvPr>
            <p:cNvSpPr txBox="1"/>
            <p:nvPr/>
          </p:nvSpPr>
          <p:spPr>
            <a:xfrm>
              <a:off x="4878857" y="3150746"/>
              <a:ext cx="367001" cy="484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28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  <p:grpSp>
        <p:nvGrpSpPr>
          <p:cNvPr id="8" name="Group 7">
            <a:extLst>
              <a:ext uri="{FF2B5EF4-FFF2-40B4-BE49-F238E27FC236}">
                <a16:creationId xmlns:a16="http://schemas.microsoft.com/office/drawing/2014/main" id="{0DA3D6D4-EE71-B340-BC40-67AF5A7312E2}"/>
              </a:ext>
            </a:extLst>
          </p:cNvPr>
          <p:cNvGrpSpPr/>
          <p:nvPr/>
        </p:nvGrpSpPr>
        <p:grpSpPr>
          <a:xfrm>
            <a:off x="200219" y="372894"/>
            <a:ext cx="5506314" cy="4279317"/>
            <a:chOff x="479856" y="3154230"/>
            <a:chExt cx="4399002" cy="3705188"/>
          </a:xfrm>
        </p:grpSpPr>
        <p:graphicFrame>
          <p:nvGraphicFramePr>
            <p:cNvPr id="9" name="Chart 8">
              <a:extLst>
                <a:ext uri="{FF2B5EF4-FFF2-40B4-BE49-F238E27FC236}">
                  <a16:creationId xmlns:a16="http://schemas.microsoft.com/office/drawing/2014/main" id="{6966D36E-EBA6-CC47-BD1E-B24BFAA9DB25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3985498804"/>
                </p:ext>
              </p:extLst>
            </p:nvPr>
          </p:nvGraphicFramePr>
          <p:xfrm>
            <a:off x="479856" y="3811418"/>
            <a:ext cx="4399002" cy="3048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82BF83A0-162B-7346-AC3D-F59AAF6B7F7E}"/>
                </a:ext>
              </a:extLst>
            </p:cNvPr>
            <p:cNvSpPr txBox="1"/>
            <p:nvPr/>
          </p:nvSpPr>
          <p:spPr>
            <a:xfrm>
              <a:off x="725406" y="3154230"/>
              <a:ext cx="338346" cy="484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28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E7F52692-E51F-4D46-8B12-D1198997C776}"/>
              </a:ext>
            </a:extLst>
          </p:cNvPr>
          <p:cNvSpPr txBox="1"/>
          <p:nvPr/>
        </p:nvSpPr>
        <p:spPr>
          <a:xfrm>
            <a:off x="200219" y="4839226"/>
            <a:ext cx="11791562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S1A and S1B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. Flow cytometric estimation of viable cells after treatment with the PEG DNA mix, estimated by autofluorescence of chlorophyll. Each column error bar shows the standard deviations for 3 independent tests. 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spcAft>
                <a:spcPts val="0"/>
              </a:spcAft>
            </a:pP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Left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GB" sz="14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trol with no PEG, then </a:t>
            </a:r>
            <a:r>
              <a:rPr lang="en-GB" sz="1400" dirty="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 after 0, 2, 5 or 20 min in the PEG MW 4000/DNA transformation mix. Cytometric measurements were done immediately after treatment (blue bars) then after 2 </a:t>
            </a:r>
            <a:r>
              <a:rPr lang="en-GB" sz="140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h (light </a:t>
            </a:r>
            <a:r>
              <a:rPr lang="en-GB" sz="1400" dirty="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green), and after 24 h (hatched pattern)</a:t>
            </a:r>
          </a:p>
          <a:p>
            <a:pPr>
              <a:spcAft>
                <a:spcPts val="0"/>
              </a:spcAft>
            </a:pPr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Right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:  </a:t>
            </a:r>
            <a:r>
              <a:rPr lang="en-GB" sz="14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effects of different MW </a:t>
            </a:r>
            <a:r>
              <a:rPr lang="en-GB" sz="1400" dirty="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PEG on cell survival. All PEG/DNA/cell transformation mixes were done for 2 min.</a:t>
            </a:r>
            <a:endParaRPr lang="en-GB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spcAft>
                <a:spcPts val="0"/>
              </a:spcAft>
            </a:pPr>
            <a:r>
              <a:rPr lang="en-GB" sz="14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asurements were made</a:t>
            </a:r>
            <a:r>
              <a:rPr lang="en-GB" sz="1400" dirty="0">
                <a:solidFill>
                  <a:srgbClr val="000000"/>
                </a:solidFill>
                <a:latin typeface="Arial" panose="020B0604020202020204" pitchFamily="34" charset="0"/>
                <a:cs typeface="Times New Roman" panose="02020603050405020304" pitchFamily="18" charset="0"/>
              </a:rPr>
              <a:t> after different recovery times in the culture room following the treatment, (T0, blue), 2 h after the treatment (T2, light green) and 24 h after the treatment (T24, hatched pattern). The 0 h cells were not treated with PEG.</a:t>
            </a:r>
            <a:endParaRPr lang="en-GB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650455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03</TotalTime>
  <Words>67</Words>
  <Application>Microsoft Macintosh PowerPoint</Application>
  <PresentationFormat>Widescreen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gel</dc:creator>
  <cp:lastModifiedBy>Nigel</cp:lastModifiedBy>
  <cp:revision>70</cp:revision>
  <cp:lastPrinted>2019-05-22T19:26:20Z</cp:lastPrinted>
  <dcterms:created xsi:type="dcterms:W3CDTF">2019-03-02T13:14:28Z</dcterms:created>
  <dcterms:modified xsi:type="dcterms:W3CDTF">2019-05-24T13:22:10Z</dcterms:modified>
</cp:coreProperties>
</file>